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8"/>
  </p:notesMasterIdLst>
  <p:sldIdLst>
    <p:sldId id="262" r:id="rId5"/>
    <p:sldId id="283" r:id="rId6"/>
    <p:sldId id="282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8ED3"/>
    <a:srgbClr val="C24EE2"/>
    <a:srgbClr val="DABCE6"/>
    <a:srgbClr val="F8C4F6"/>
    <a:srgbClr val="FBD9E8"/>
    <a:srgbClr val="5BD4FF"/>
    <a:srgbClr val="F67E9B"/>
    <a:srgbClr val="FBFCC8"/>
    <a:srgbClr val="44ECC0"/>
    <a:srgbClr val="51D1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631273-7CD6-11B5-4879-30670D4B7BFD}" v="8" dt="2021-09-30T05:41:18.9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15" autoAdjust="0"/>
    <p:restoredTop sz="94935" autoAdjust="0"/>
  </p:normalViewPr>
  <p:slideViewPr>
    <p:cSldViewPr snapToGrid="0">
      <p:cViewPr varScale="1">
        <p:scale>
          <a:sx n="58" d="100"/>
          <a:sy n="58" d="100"/>
        </p:scale>
        <p:origin x="30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ioce Mario" userId="S::m.cioce@unicampus.it::64a03e3b-6f49-4619-8d84-1318f0838d14" providerId="AD" clId="Web-{24631273-7CD6-11B5-4879-30670D4B7BFD}"/>
    <pc:docChg chg="modSld">
      <pc:chgData name="Cioce Mario" userId="S::m.cioce@unicampus.it::64a03e3b-6f49-4619-8d84-1318f0838d14" providerId="AD" clId="Web-{24631273-7CD6-11B5-4879-30670D4B7BFD}" dt="2021-09-30T05:41:18.927" v="7" actId="1076"/>
      <pc:docMkLst>
        <pc:docMk/>
      </pc:docMkLst>
      <pc:sldChg chg="modSp">
        <pc:chgData name="Cioce Mario" userId="S::m.cioce@unicampus.it::64a03e3b-6f49-4619-8d84-1318f0838d14" providerId="AD" clId="Web-{24631273-7CD6-11B5-4879-30670D4B7BFD}" dt="2021-09-30T05:41:18.927" v="7" actId="1076"/>
        <pc:sldMkLst>
          <pc:docMk/>
          <pc:sldMk cId="2309576355" sldId="270"/>
        </pc:sldMkLst>
        <pc:spChg chg="mod">
          <ac:chgData name="Cioce Mario" userId="S::m.cioce@unicampus.it::64a03e3b-6f49-4619-8d84-1318f0838d14" providerId="AD" clId="Web-{24631273-7CD6-11B5-4879-30670D4B7BFD}" dt="2021-09-30T05:41:18.927" v="7" actId="1076"/>
          <ac:spMkLst>
            <pc:docMk/>
            <pc:sldMk cId="2309576355" sldId="270"/>
            <ac:spMk id="17" creationId="{00000000-0000-0000-0000-000000000000}"/>
          </ac:spMkLst>
        </pc:spChg>
        <pc:spChg chg="mod">
          <ac:chgData name="Cioce Mario" userId="S::m.cioce@unicampus.it::64a03e3b-6f49-4619-8d84-1318f0838d14" providerId="AD" clId="Web-{24631273-7CD6-11B5-4879-30670D4B7BFD}" dt="2021-09-30T05:40:42.285" v="1"/>
          <ac:spMkLst>
            <pc:docMk/>
            <pc:sldMk cId="2309576355" sldId="270"/>
            <ac:spMk id="19" creationId="{00000000-0000-0000-0000-000000000000}"/>
          </ac:spMkLst>
        </pc:spChg>
        <pc:spChg chg="mod">
          <ac:chgData name="Cioce Mario" userId="S::m.cioce@unicampus.it::64a03e3b-6f49-4619-8d84-1318f0838d14" providerId="AD" clId="Web-{24631273-7CD6-11B5-4879-30670D4B7BFD}" dt="2021-09-30T05:40:42.348" v="3"/>
          <ac:spMkLst>
            <pc:docMk/>
            <pc:sldMk cId="2309576355" sldId="270"/>
            <ac:spMk id="21" creationId="{00000000-0000-0000-0000-000000000000}"/>
          </ac:spMkLst>
        </pc:spChg>
        <pc:picChg chg="mod">
          <ac:chgData name="Cioce Mario" userId="S::m.cioce@unicampus.it::64a03e3b-6f49-4619-8d84-1318f0838d14" providerId="AD" clId="Web-{24631273-7CD6-11B5-4879-30670D4B7BFD}" dt="2021-09-30T05:40:42.254" v="0"/>
          <ac:picMkLst>
            <pc:docMk/>
            <pc:sldMk cId="2309576355" sldId="270"/>
            <ac:picMk id="8" creationId="{00000000-0000-0000-0000-000000000000}"/>
          </ac:picMkLst>
        </pc:picChg>
        <pc:picChg chg="mod">
          <ac:chgData name="Cioce Mario" userId="S::m.cioce@unicampus.it::64a03e3b-6f49-4619-8d84-1318f0838d14" providerId="AD" clId="Web-{24631273-7CD6-11B5-4879-30670D4B7BFD}" dt="2021-09-30T05:40:51.317" v="6"/>
          <ac:picMkLst>
            <pc:docMk/>
            <pc:sldMk cId="2309576355" sldId="270"/>
            <ac:picMk id="9" creationId="{00000000-0000-0000-0000-000000000000}"/>
          </ac:picMkLst>
        </pc:picChg>
        <pc:cxnChg chg="mod">
          <ac:chgData name="Cioce Mario" userId="S::m.cioce@unicampus.it::64a03e3b-6f49-4619-8d84-1318f0838d14" providerId="AD" clId="Web-{24631273-7CD6-11B5-4879-30670D4B7BFD}" dt="2021-09-30T05:40:42.316" v="2"/>
          <ac:cxnSpMkLst>
            <pc:docMk/>
            <pc:sldMk cId="2309576355" sldId="270"/>
            <ac:cxnSpMk id="20" creationId="{00000000-0000-0000-0000-000000000000}"/>
          </ac:cxnSpMkLst>
        </pc:cxnChg>
        <pc:cxnChg chg="mod">
          <ac:chgData name="Cioce Mario" userId="S::m.cioce@unicampus.it::64a03e3b-6f49-4619-8d84-1318f0838d14" providerId="AD" clId="Web-{24631273-7CD6-11B5-4879-30670D4B7BFD}" dt="2021-09-30T05:40:42.379" v="4"/>
          <ac:cxnSpMkLst>
            <pc:docMk/>
            <pc:sldMk cId="2309576355" sldId="270"/>
            <ac:cxnSpMk id="22" creationId="{00000000-0000-0000-0000-000000000000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Excel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Affymetrix vs Q-PCR</a:t>
            </a:r>
          </a:p>
        </c:rich>
      </c:tx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972758784604389"/>
          <c:y val="0.17238590762751949"/>
          <c:w val="0.81508183802173928"/>
          <c:h val="0.551066420074507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or lin corr'!$H$1</c:f>
              <c:strCache>
                <c:ptCount val="1"/>
                <c:pt idx="0">
                  <c:v>Affymetrix</c:v>
                </c:pt>
              </c:strCache>
            </c:strRef>
          </c:tx>
          <c:spPr>
            <a:pattFill prst="pct20">
              <a:fgClr>
                <a:schemeClr val="tx2"/>
              </a:fgClr>
              <a:bgClr>
                <a:schemeClr val="bg1"/>
              </a:bgClr>
            </a:pattFill>
            <a:ln w="12700">
              <a:solidFill>
                <a:schemeClr val="tx2"/>
              </a:solidFill>
            </a:ln>
            <a:effectLst/>
          </c:spPr>
          <c:invertIfNegative val="0"/>
          <c:cat>
            <c:strRef>
              <c:f>'for lin corr'!$G$2:$G$35</c:f>
              <c:strCache>
                <c:ptCount val="34"/>
                <c:pt idx="0">
                  <c:v>ASF1B</c:v>
                </c:pt>
                <c:pt idx="1">
                  <c:v>ATAD5</c:v>
                </c:pt>
                <c:pt idx="2">
                  <c:v>BRIP1</c:v>
                </c:pt>
                <c:pt idx="3">
                  <c:v>CCNE1</c:v>
                </c:pt>
                <c:pt idx="4">
                  <c:v>CCNE2</c:v>
                </c:pt>
                <c:pt idx="5">
                  <c:v>CLSPN</c:v>
                </c:pt>
                <c:pt idx="6">
                  <c:v>ESCO2</c:v>
                </c:pt>
                <c:pt idx="7">
                  <c:v>EXO1</c:v>
                </c:pt>
                <c:pt idx="8">
                  <c:v>FEN1</c:v>
                </c:pt>
                <c:pt idx="9">
                  <c:v>GPR75</c:v>
                </c:pt>
                <c:pt idx="10">
                  <c:v>HIST1H1B</c:v>
                </c:pt>
                <c:pt idx="11">
                  <c:v>MCTP1</c:v>
                </c:pt>
                <c:pt idx="12">
                  <c:v>PNP</c:v>
                </c:pt>
                <c:pt idx="13">
                  <c:v>PTX3</c:v>
                </c:pt>
                <c:pt idx="14">
                  <c:v>RRM2</c:v>
                </c:pt>
                <c:pt idx="15">
                  <c:v>SPC24</c:v>
                </c:pt>
                <c:pt idx="16">
                  <c:v>SPC25</c:v>
                </c:pt>
                <c:pt idx="17">
                  <c:v>ULBP3</c:v>
                </c:pt>
                <c:pt idx="18">
                  <c:v>ZWINT</c:v>
                </c:pt>
                <c:pt idx="19">
                  <c:v>TNFRSF11B</c:v>
                </c:pt>
                <c:pt idx="20">
                  <c:v>TSPAN2</c:v>
                </c:pt>
                <c:pt idx="21">
                  <c:v>TNFSF4</c:v>
                </c:pt>
                <c:pt idx="22">
                  <c:v>TNFRSF9</c:v>
                </c:pt>
                <c:pt idx="23">
                  <c:v>IGFL3</c:v>
                </c:pt>
                <c:pt idx="24">
                  <c:v>TLL1</c:v>
                </c:pt>
                <c:pt idx="25">
                  <c:v>DDIT4</c:v>
                </c:pt>
                <c:pt idx="26">
                  <c:v>CLDN1</c:v>
                </c:pt>
                <c:pt idx="27">
                  <c:v>TRIB3</c:v>
                </c:pt>
                <c:pt idx="28">
                  <c:v>ANKRD1</c:v>
                </c:pt>
                <c:pt idx="29">
                  <c:v>GPC6</c:v>
                </c:pt>
                <c:pt idx="30">
                  <c:v>DRAM1</c:v>
                </c:pt>
                <c:pt idx="31">
                  <c:v>AMIGO2</c:v>
                </c:pt>
                <c:pt idx="32">
                  <c:v>ABCC3</c:v>
                </c:pt>
                <c:pt idx="33">
                  <c:v>SLC12A8</c:v>
                </c:pt>
              </c:strCache>
            </c:strRef>
          </c:cat>
          <c:val>
            <c:numRef>
              <c:f>'for lin corr'!$H$2:$H$35</c:f>
              <c:numCache>
                <c:formatCode>0.0</c:formatCode>
                <c:ptCount val="34"/>
                <c:pt idx="0">
                  <c:v>-2.36112992326091</c:v>
                </c:pt>
                <c:pt idx="1">
                  <c:v>-2.3314342037052298</c:v>
                </c:pt>
                <c:pt idx="2">
                  <c:v>-2.6443981150363398</c:v>
                </c:pt>
                <c:pt idx="3">
                  <c:v>-2.3491212988157399</c:v>
                </c:pt>
                <c:pt idx="4">
                  <c:v>-2.59538086561273</c:v>
                </c:pt>
                <c:pt idx="5">
                  <c:v>-2.5870937142656598</c:v>
                </c:pt>
                <c:pt idx="6">
                  <c:v>-3.4788563496838698</c:v>
                </c:pt>
                <c:pt idx="7">
                  <c:v>-3.3690080974186301</c:v>
                </c:pt>
                <c:pt idx="8">
                  <c:v>-2.1926357153625302</c:v>
                </c:pt>
                <c:pt idx="9">
                  <c:v>-2.69142146392669</c:v>
                </c:pt>
                <c:pt idx="10">
                  <c:v>-2.9186466532434898</c:v>
                </c:pt>
                <c:pt idx="11">
                  <c:v>-3.7469321599971002</c:v>
                </c:pt>
                <c:pt idx="12">
                  <c:v>-2.6034127725507199</c:v>
                </c:pt>
                <c:pt idx="13">
                  <c:v>-3.0132643557992802</c:v>
                </c:pt>
                <c:pt idx="14">
                  <c:v>-2.6982300429468302</c:v>
                </c:pt>
                <c:pt idx="15">
                  <c:v>-2.3061889865311098</c:v>
                </c:pt>
                <c:pt idx="16">
                  <c:v>-2.30639967124853</c:v>
                </c:pt>
                <c:pt idx="17">
                  <c:v>-3.8726223646312499</c:v>
                </c:pt>
                <c:pt idx="18">
                  <c:v>-2.3533727879464901</c:v>
                </c:pt>
                <c:pt idx="19">
                  <c:v>5.5077042482963998</c:v>
                </c:pt>
                <c:pt idx="20">
                  <c:v>3.8233706065324098</c:v>
                </c:pt>
                <c:pt idx="21">
                  <c:v>3.4165693455859598</c:v>
                </c:pt>
                <c:pt idx="22">
                  <c:v>2.6967153555568002</c:v>
                </c:pt>
                <c:pt idx="23">
                  <c:v>2.6122745398077001</c:v>
                </c:pt>
                <c:pt idx="24">
                  <c:v>2.6120536652105599</c:v>
                </c:pt>
                <c:pt idx="25">
                  <c:v>2.5961941993792301</c:v>
                </c:pt>
                <c:pt idx="26">
                  <c:v>2.3897658211566499</c:v>
                </c:pt>
                <c:pt idx="27">
                  <c:v>2.28922341385142</c:v>
                </c:pt>
                <c:pt idx="28">
                  <c:v>2.2787295082364301</c:v>
                </c:pt>
                <c:pt idx="29">
                  <c:v>2.19137114349871</c:v>
                </c:pt>
                <c:pt idx="30">
                  <c:v>2.1272333644091601</c:v>
                </c:pt>
                <c:pt idx="31">
                  <c:v>1.99855310535979</c:v>
                </c:pt>
                <c:pt idx="32">
                  <c:v>1.99717361111338</c:v>
                </c:pt>
                <c:pt idx="33">
                  <c:v>1.951949858442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58F-46DB-9B83-7D002E5CFF09}"/>
            </c:ext>
          </c:extLst>
        </c:ser>
        <c:ser>
          <c:idx val="1"/>
          <c:order val="1"/>
          <c:tx>
            <c:strRef>
              <c:f>'for lin corr'!$I$1</c:f>
              <c:strCache>
                <c:ptCount val="1"/>
                <c:pt idx="0">
                  <c:v>Q-PCR</c:v>
                </c:pt>
              </c:strCache>
            </c:strRef>
          </c:tx>
          <c:spPr>
            <a:pattFill prst="pct50">
              <a:fgClr>
                <a:schemeClr val="tx2"/>
              </a:fgClr>
              <a:bgClr>
                <a:schemeClr val="bg1"/>
              </a:bgClr>
            </a:pattFill>
            <a:ln>
              <a:solidFill>
                <a:schemeClr val="tx2"/>
              </a:solidFill>
            </a:ln>
            <a:effectLst/>
          </c:spPr>
          <c:invertIfNegative val="0"/>
          <c:cat>
            <c:strRef>
              <c:f>'for lin corr'!$G$2:$G$35</c:f>
              <c:strCache>
                <c:ptCount val="34"/>
                <c:pt idx="0">
                  <c:v>ASF1B</c:v>
                </c:pt>
                <c:pt idx="1">
                  <c:v>ATAD5</c:v>
                </c:pt>
                <c:pt idx="2">
                  <c:v>BRIP1</c:v>
                </c:pt>
                <c:pt idx="3">
                  <c:v>CCNE1</c:v>
                </c:pt>
                <c:pt idx="4">
                  <c:v>CCNE2</c:v>
                </c:pt>
                <c:pt idx="5">
                  <c:v>CLSPN</c:v>
                </c:pt>
                <c:pt idx="6">
                  <c:v>ESCO2</c:v>
                </c:pt>
                <c:pt idx="7">
                  <c:v>EXO1</c:v>
                </c:pt>
                <c:pt idx="8">
                  <c:v>FEN1</c:v>
                </c:pt>
                <c:pt idx="9">
                  <c:v>GPR75</c:v>
                </c:pt>
                <c:pt idx="10">
                  <c:v>HIST1H1B</c:v>
                </c:pt>
                <c:pt idx="11">
                  <c:v>MCTP1</c:v>
                </c:pt>
                <c:pt idx="12">
                  <c:v>PNP</c:v>
                </c:pt>
                <c:pt idx="13">
                  <c:v>PTX3</c:v>
                </c:pt>
                <c:pt idx="14">
                  <c:v>RRM2</c:v>
                </c:pt>
                <c:pt idx="15">
                  <c:v>SPC24</c:v>
                </c:pt>
                <c:pt idx="16">
                  <c:v>SPC25</c:v>
                </c:pt>
                <c:pt idx="17">
                  <c:v>ULBP3</c:v>
                </c:pt>
                <c:pt idx="18">
                  <c:v>ZWINT</c:v>
                </c:pt>
                <c:pt idx="19">
                  <c:v>TNFRSF11B</c:v>
                </c:pt>
                <c:pt idx="20">
                  <c:v>TSPAN2</c:v>
                </c:pt>
                <c:pt idx="21">
                  <c:v>TNFSF4</c:v>
                </c:pt>
                <c:pt idx="22">
                  <c:v>TNFRSF9</c:v>
                </c:pt>
                <c:pt idx="23">
                  <c:v>IGFL3</c:v>
                </c:pt>
                <c:pt idx="24">
                  <c:v>TLL1</c:v>
                </c:pt>
                <c:pt idx="25">
                  <c:v>DDIT4</c:v>
                </c:pt>
                <c:pt idx="26">
                  <c:v>CLDN1</c:v>
                </c:pt>
                <c:pt idx="27">
                  <c:v>TRIB3</c:v>
                </c:pt>
                <c:pt idx="28">
                  <c:v>ANKRD1</c:v>
                </c:pt>
                <c:pt idx="29">
                  <c:v>GPC6</c:v>
                </c:pt>
                <c:pt idx="30">
                  <c:v>DRAM1</c:v>
                </c:pt>
                <c:pt idx="31">
                  <c:v>AMIGO2</c:v>
                </c:pt>
                <c:pt idx="32">
                  <c:v>ABCC3</c:v>
                </c:pt>
                <c:pt idx="33">
                  <c:v>SLC12A8</c:v>
                </c:pt>
              </c:strCache>
            </c:strRef>
          </c:cat>
          <c:val>
            <c:numRef>
              <c:f>'for lin corr'!$I$2:$I$35</c:f>
              <c:numCache>
                <c:formatCode>General</c:formatCode>
                <c:ptCount val="34"/>
                <c:pt idx="0">
                  <c:v>-3.5549999999999997</c:v>
                </c:pt>
                <c:pt idx="1">
                  <c:v>-2.2549999999999999</c:v>
                </c:pt>
                <c:pt idx="2">
                  <c:v>-3.5750000000000002</c:v>
                </c:pt>
                <c:pt idx="3">
                  <c:v>-3.5949999999999998</c:v>
                </c:pt>
                <c:pt idx="4">
                  <c:v>-2.9249999999999998</c:v>
                </c:pt>
                <c:pt idx="5">
                  <c:v>-2.7749999999999995</c:v>
                </c:pt>
                <c:pt idx="6">
                  <c:v>1.08</c:v>
                </c:pt>
                <c:pt idx="7">
                  <c:v>-2.0750000000000002</c:v>
                </c:pt>
                <c:pt idx="8">
                  <c:v>-3.6749999999999998</c:v>
                </c:pt>
                <c:pt idx="9">
                  <c:v>-3.1749999999999998</c:v>
                </c:pt>
                <c:pt idx="10">
                  <c:v>-4.6750000000000007</c:v>
                </c:pt>
                <c:pt idx="11">
                  <c:v>-3.9750000000000001</c:v>
                </c:pt>
                <c:pt idx="12">
                  <c:v>-2.2750000000000004</c:v>
                </c:pt>
                <c:pt idx="13">
                  <c:v>-3.2749999999999995</c:v>
                </c:pt>
                <c:pt idx="14">
                  <c:v>-3.1749999999999998</c:v>
                </c:pt>
                <c:pt idx="15">
                  <c:v>-3.5750000000000002</c:v>
                </c:pt>
                <c:pt idx="16">
                  <c:v>-3.7749999999999995</c:v>
                </c:pt>
                <c:pt idx="17">
                  <c:v>1.23</c:v>
                </c:pt>
                <c:pt idx="18">
                  <c:v>-2.5750000000000002</c:v>
                </c:pt>
                <c:pt idx="19">
                  <c:v>8.5749999999999993</c:v>
                </c:pt>
                <c:pt idx="20">
                  <c:v>3.4750000000000001</c:v>
                </c:pt>
                <c:pt idx="21">
                  <c:v>4.4749999999999996</c:v>
                </c:pt>
                <c:pt idx="22">
                  <c:v>2.7749999999999999</c:v>
                </c:pt>
                <c:pt idx="23">
                  <c:v>2.0750000000000002</c:v>
                </c:pt>
                <c:pt idx="24">
                  <c:v>2.5750000000000002</c:v>
                </c:pt>
                <c:pt idx="25">
                  <c:v>3.2749999999999999</c:v>
                </c:pt>
                <c:pt idx="26">
                  <c:v>3.7149999999999999</c:v>
                </c:pt>
                <c:pt idx="27">
                  <c:v>2.4750000000000001</c:v>
                </c:pt>
                <c:pt idx="28">
                  <c:v>1.875</c:v>
                </c:pt>
                <c:pt idx="29">
                  <c:v>2.1749999999999998</c:v>
                </c:pt>
                <c:pt idx="30">
                  <c:v>3.6749999999999998</c:v>
                </c:pt>
                <c:pt idx="31">
                  <c:v>1.675</c:v>
                </c:pt>
                <c:pt idx="32">
                  <c:v>1.7150000000000001</c:v>
                </c:pt>
                <c:pt idx="33">
                  <c:v>2.615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58F-46DB-9B83-7D002E5CFF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643416"/>
        <c:axId val="187645376"/>
      </c:barChart>
      <c:catAx>
        <c:axId val="187643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sz="800"/>
            </a:pPr>
            <a:endParaRPr lang="en-US"/>
          </a:p>
        </c:txPr>
        <c:crossAx val="187645376"/>
        <c:crosses val="autoZero"/>
        <c:auto val="0"/>
        <c:lblAlgn val="ctr"/>
        <c:lblOffset val="100"/>
        <c:noMultiLvlLbl val="0"/>
      </c:catAx>
      <c:valAx>
        <c:axId val="187645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modulation (ALDHbright/ALDHlow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8764341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6584041452383056"/>
          <c:y val="3.1760088666157843E-2"/>
          <c:w val="0.14809685530019753"/>
          <c:h val="0.23094253506154061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10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08BE74-4678-4CA7-A6C9-8587023BF5A5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7BE0AE-4054-45C7-AE6F-A02AA7D0674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311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. ALDH</a:t>
            </a:r>
            <a:r>
              <a:rPr lang="en-US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ight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and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DH</a:t>
            </a:r>
            <a:r>
              <a:rPr lang="en-US" sz="1200" b="1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are endowed with different gene expression profile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 both steady state and afte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utei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. A.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ing the levels of expression of 924 genes differentially expressed (p&gt;0.05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score normalized) among the 4 cell subpopulations indicated. Log2 expression is shown, scaled so that red and blue indicate expression values ≥ 2 standard deviations above and below, respectively, the row-wise mean (white) computed across all samples The 924 genes were arbitrarily broken up into 10 clusters according to  similar patterns of differential expression. .Eight clusters (cluster 1-8) selected based on similarity in were identified and reported.  B. PCA plots showing the distribution of the cell subpopulations considered in A.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7BE0AE-4054-45C7-AE6F-A02AA7D0674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8906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5. Validation of the gene expression result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Histogram reporting the QRT-PCR analysis of 34 representative transcripts from the gene expression profile obtained. B. Correlation analysis between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ffymetrix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ormalized intensity values and the QRT-PCR expression data.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ed as fold over ctrl (FOC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quare is  indicated</a:t>
            </a:r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7BE0AE-4054-45C7-AE6F-A02AA7D0674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452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588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60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68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411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743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12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419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906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993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75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763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9F949-47A4-4692-B003-1C66CABF068F}" type="datetimeFigureOut">
              <a:rPr lang="en-US" smtClean="0"/>
              <a:t>1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8857-FA78-4787-872E-A9AABD41F0C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932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CasellaDiTesto 38"/>
          <p:cNvSpPr txBox="1"/>
          <p:nvPr/>
        </p:nvSpPr>
        <p:spPr>
          <a:xfrm>
            <a:off x="-73627" y="-85725"/>
            <a:ext cx="13676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4">
            <a:extLst>
              <a:ext uri="{FF2B5EF4-FFF2-40B4-BE49-F238E27FC236}">
                <a16:creationId xmlns="" xmlns:a16="http://schemas.microsoft.com/office/drawing/2014/main" id="{B7EA3686-6D48-314E-AFE4-B3B90DBB6F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3547" y="1320425"/>
            <a:ext cx="2453691" cy="2042757"/>
          </a:xfrm>
          <a:prstGeom prst="rect">
            <a:avLst/>
          </a:prstGeom>
        </p:spPr>
      </p:pic>
      <p:sp>
        <p:nvSpPr>
          <p:cNvPr id="47" name="TextBox 5">
            <a:extLst>
              <a:ext uri="{FF2B5EF4-FFF2-40B4-BE49-F238E27FC236}">
                <a16:creationId xmlns="" xmlns:a16="http://schemas.microsoft.com/office/drawing/2014/main" id="{A57EF061-8642-0C49-B615-56F36D18EDB5}"/>
              </a:ext>
            </a:extLst>
          </p:cNvPr>
          <p:cNvSpPr txBox="1"/>
          <p:nvPr/>
        </p:nvSpPr>
        <p:spPr>
          <a:xfrm rot="16200000">
            <a:off x="606047" y="2042084"/>
            <a:ext cx="13099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stance on PC1</a:t>
            </a:r>
          </a:p>
        </p:txBody>
      </p:sp>
      <p:sp>
        <p:nvSpPr>
          <p:cNvPr id="48" name="Rettangolo 10">
            <a:extLst>
              <a:ext uri="{FF2B5EF4-FFF2-40B4-BE49-F238E27FC236}">
                <a16:creationId xmlns="" xmlns:a16="http://schemas.microsoft.com/office/drawing/2014/main" id="{A577F60B-E79D-F94F-AA2B-BBDA8C731607}"/>
              </a:ext>
            </a:extLst>
          </p:cNvPr>
          <p:cNvSpPr/>
          <p:nvPr/>
        </p:nvSpPr>
        <p:spPr>
          <a:xfrm>
            <a:off x="2757325" y="3299528"/>
            <a:ext cx="732893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969" dirty="0" err="1">
                <a:latin typeface="Arial" panose="020B0604020202020204" pitchFamily="34" charset="0"/>
                <a:cs typeface="Arial" panose="020B0604020202020204" pitchFamily="34" charset="0"/>
              </a:rPr>
              <a:t>ALDH</a:t>
            </a:r>
            <a:r>
              <a:rPr lang="it-IT" sz="969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it-IT" sz="969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69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969" dirty="0"/>
          </a:p>
        </p:txBody>
      </p:sp>
      <p:sp>
        <p:nvSpPr>
          <p:cNvPr id="49" name="Rettangolo 11">
            <a:extLst>
              <a:ext uri="{FF2B5EF4-FFF2-40B4-BE49-F238E27FC236}">
                <a16:creationId xmlns="" xmlns:a16="http://schemas.microsoft.com/office/drawing/2014/main" id="{29A06310-F6B5-AB49-A681-621F0013B990}"/>
              </a:ext>
            </a:extLst>
          </p:cNvPr>
          <p:cNvSpPr/>
          <p:nvPr/>
        </p:nvSpPr>
        <p:spPr>
          <a:xfrm>
            <a:off x="1818460" y="3299528"/>
            <a:ext cx="723274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969" dirty="0" err="1">
                <a:latin typeface="Arial" panose="020B0604020202020204" pitchFamily="34" charset="0"/>
                <a:cs typeface="Arial" panose="020B0604020202020204" pitchFamily="34" charset="0"/>
              </a:rPr>
              <a:t>ALDH</a:t>
            </a:r>
            <a:r>
              <a:rPr lang="it-IT" sz="969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endParaRPr lang="en-US" sz="969" dirty="0"/>
          </a:p>
        </p:txBody>
      </p:sp>
      <p:cxnSp>
        <p:nvCxnSpPr>
          <p:cNvPr id="50" name="Connettore 1 13">
            <a:extLst>
              <a:ext uri="{FF2B5EF4-FFF2-40B4-BE49-F238E27FC236}">
                <a16:creationId xmlns="" xmlns:a16="http://schemas.microsoft.com/office/drawing/2014/main" id="{22E7466D-067C-374D-8D4F-96B436591F60}"/>
              </a:ext>
            </a:extLst>
          </p:cNvPr>
          <p:cNvCxnSpPr/>
          <p:nvPr/>
        </p:nvCxnSpPr>
        <p:spPr>
          <a:xfrm>
            <a:off x="2792240" y="3324122"/>
            <a:ext cx="59791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ttore 1 14">
            <a:extLst>
              <a:ext uri="{FF2B5EF4-FFF2-40B4-BE49-F238E27FC236}">
                <a16:creationId xmlns="" xmlns:a16="http://schemas.microsoft.com/office/drawing/2014/main" id="{27EEF64D-1AE4-7D44-BB65-D910B77218CD}"/>
              </a:ext>
            </a:extLst>
          </p:cNvPr>
          <p:cNvCxnSpPr/>
          <p:nvPr/>
        </p:nvCxnSpPr>
        <p:spPr>
          <a:xfrm>
            <a:off x="1871448" y="3315642"/>
            <a:ext cx="59791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2" name="Group 9">
            <a:extLst>
              <a:ext uri="{FF2B5EF4-FFF2-40B4-BE49-F238E27FC236}">
                <a16:creationId xmlns="" xmlns:a16="http://schemas.microsoft.com/office/drawing/2014/main" id="{97202AA2-5C11-464A-9005-E65258898867}"/>
              </a:ext>
            </a:extLst>
          </p:cNvPr>
          <p:cNvGrpSpPr/>
          <p:nvPr/>
        </p:nvGrpSpPr>
        <p:grpSpPr>
          <a:xfrm>
            <a:off x="3683672" y="1255271"/>
            <a:ext cx="386316" cy="430887"/>
            <a:chOff x="5544123" y="2968868"/>
            <a:chExt cx="386316" cy="430887"/>
          </a:xfrm>
        </p:grpSpPr>
        <p:sp>
          <p:nvSpPr>
            <p:cNvPr id="53" name="Rectangle 6">
              <a:extLst>
                <a:ext uri="{FF2B5EF4-FFF2-40B4-BE49-F238E27FC236}">
                  <a16:creationId xmlns="" xmlns:a16="http://schemas.microsoft.com/office/drawing/2014/main" id="{2F3C76E2-CDB4-FD43-B1BE-733AC5F08850}"/>
                </a:ext>
              </a:extLst>
            </p:cNvPr>
            <p:cNvSpPr/>
            <p:nvPr/>
          </p:nvSpPr>
          <p:spPr>
            <a:xfrm>
              <a:off x="5544123" y="3076398"/>
              <a:ext cx="141268" cy="698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Rectangle 73">
              <a:extLst>
                <a:ext uri="{FF2B5EF4-FFF2-40B4-BE49-F238E27FC236}">
                  <a16:creationId xmlns="" xmlns:a16="http://schemas.microsoft.com/office/drawing/2014/main" id="{40E6B243-A22A-5046-9CEE-B19CD86BD5F1}"/>
                </a:ext>
              </a:extLst>
            </p:cNvPr>
            <p:cNvSpPr/>
            <p:nvPr/>
          </p:nvSpPr>
          <p:spPr>
            <a:xfrm>
              <a:off x="5544123" y="3242582"/>
              <a:ext cx="141268" cy="69850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8">
              <a:extLst>
                <a:ext uri="{FF2B5EF4-FFF2-40B4-BE49-F238E27FC236}">
                  <a16:creationId xmlns="" xmlns:a16="http://schemas.microsoft.com/office/drawing/2014/main" id="{885C72B2-5C20-2B45-A31C-67DB2249F624}"/>
                </a:ext>
              </a:extLst>
            </p:cNvPr>
            <p:cNvSpPr txBox="1"/>
            <p:nvPr/>
          </p:nvSpPr>
          <p:spPr>
            <a:xfrm>
              <a:off x="5643181" y="2968868"/>
              <a:ext cx="28725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uppo 6"/>
          <p:cNvGrpSpPr/>
          <p:nvPr/>
        </p:nvGrpSpPr>
        <p:grpSpPr>
          <a:xfrm flipH="1">
            <a:off x="2779122" y="1545639"/>
            <a:ext cx="688828" cy="485464"/>
            <a:chOff x="4660453" y="2107254"/>
            <a:chExt cx="597958" cy="441714"/>
          </a:xfrm>
        </p:grpSpPr>
        <p:cxnSp>
          <p:nvCxnSpPr>
            <p:cNvPr id="56" name="Connettore 1 55"/>
            <p:cNvCxnSpPr/>
            <p:nvPr/>
          </p:nvCxnSpPr>
          <p:spPr>
            <a:xfrm flipH="1">
              <a:off x="4691595" y="2107254"/>
              <a:ext cx="383458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 flipH="1" flipV="1">
              <a:off x="5167514" y="2185225"/>
              <a:ext cx="0" cy="642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88" name="Gruppo 87"/>
            <p:cNvGrpSpPr/>
            <p:nvPr/>
          </p:nvGrpSpPr>
          <p:grpSpPr>
            <a:xfrm flipH="1">
              <a:off x="4660453" y="2530985"/>
              <a:ext cx="199345" cy="17983"/>
              <a:chOff x="2309169" y="4880824"/>
              <a:chExt cx="1320383" cy="44047"/>
            </a:xfrm>
          </p:grpSpPr>
          <p:cxnSp>
            <p:nvCxnSpPr>
              <p:cNvPr id="89" name="Connettore 1 88"/>
              <p:cNvCxnSpPr/>
              <p:nvPr/>
            </p:nvCxnSpPr>
            <p:spPr>
              <a:xfrm>
                <a:off x="2309169" y="4880824"/>
                <a:ext cx="1296935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ttore 1 89"/>
              <p:cNvCxnSpPr/>
              <p:nvPr/>
            </p:nvCxnSpPr>
            <p:spPr>
              <a:xfrm>
                <a:off x="3629552" y="4881482"/>
                <a:ext cx="0" cy="4338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ttore 1 90"/>
              <p:cNvCxnSpPr/>
              <p:nvPr/>
            </p:nvCxnSpPr>
            <p:spPr>
              <a:xfrm>
                <a:off x="2339513" y="4880824"/>
                <a:ext cx="0" cy="4338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uppo 91"/>
            <p:cNvGrpSpPr/>
            <p:nvPr/>
          </p:nvGrpSpPr>
          <p:grpSpPr>
            <a:xfrm flipH="1">
              <a:off x="5080406" y="2243287"/>
              <a:ext cx="178005" cy="23936"/>
              <a:chOff x="2335325" y="4880824"/>
              <a:chExt cx="1296937" cy="44047"/>
            </a:xfrm>
          </p:grpSpPr>
          <p:cxnSp>
            <p:nvCxnSpPr>
              <p:cNvPr id="93" name="Connettore 1 92"/>
              <p:cNvCxnSpPr/>
              <p:nvPr/>
            </p:nvCxnSpPr>
            <p:spPr>
              <a:xfrm>
                <a:off x="2335325" y="4880824"/>
                <a:ext cx="129693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ttore 1 93"/>
              <p:cNvCxnSpPr/>
              <p:nvPr/>
            </p:nvCxnSpPr>
            <p:spPr>
              <a:xfrm>
                <a:off x="3629552" y="4881482"/>
                <a:ext cx="0" cy="4338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nettore 1 94"/>
              <p:cNvCxnSpPr/>
              <p:nvPr/>
            </p:nvCxnSpPr>
            <p:spPr>
              <a:xfrm>
                <a:off x="2339513" y="4880824"/>
                <a:ext cx="0" cy="4338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6" name="Connettore 1 95"/>
            <p:cNvCxnSpPr/>
            <p:nvPr/>
          </p:nvCxnSpPr>
          <p:spPr>
            <a:xfrm flipH="1" flipV="1">
              <a:off x="4761703" y="2177871"/>
              <a:ext cx="0" cy="3570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Connettore 1 96"/>
            <p:cNvCxnSpPr/>
            <p:nvPr/>
          </p:nvCxnSpPr>
          <p:spPr>
            <a:xfrm flipH="1">
              <a:off x="4750050" y="2177012"/>
              <a:ext cx="419727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TextBox 40">
            <a:extLst>
              <a:ext uri="{FF2B5EF4-FFF2-40B4-BE49-F238E27FC236}">
                <a16:creationId xmlns="" xmlns:a16="http://schemas.microsoft.com/office/drawing/2014/main" id="{9179058E-AC30-B14F-93B3-C36A99FFBE88}"/>
              </a:ext>
            </a:extLst>
          </p:cNvPr>
          <p:cNvSpPr txBox="1"/>
          <p:nvPr/>
        </p:nvSpPr>
        <p:spPr>
          <a:xfrm flipH="1">
            <a:off x="2985259" y="1473406"/>
            <a:ext cx="243978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06" name="Connettore 1 105"/>
          <p:cNvCxnSpPr/>
          <p:nvPr/>
        </p:nvCxnSpPr>
        <p:spPr>
          <a:xfrm>
            <a:off x="2008163" y="1470715"/>
            <a:ext cx="44173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ttore 1 106"/>
          <p:cNvCxnSpPr/>
          <p:nvPr/>
        </p:nvCxnSpPr>
        <p:spPr>
          <a:xfrm flipV="1">
            <a:off x="1866962" y="1601470"/>
            <a:ext cx="0" cy="362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08" name="Gruppo 107"/>
          <p:cNvGrpSpPr/>
          <p:nvPr/>
        </p:nvGrpSpPr>
        <p:grpSpPr>
          <a:xfrm>
            <a:off x="2264832" y="2976424"/>
            <a:ext cx="229639" cy="19764"/>
            <a:chOff x="2309169" y="4880824"/>
            <a:chExt cx="1320383" cy="44047"/>
          </a:xfrm>
        </p:grpSpPr>
        <p:cxnSp>
          <p:nvCxnSpPr>
            <p:cNvPr id="115" name="Connettore 1 114"/>
            <p:cNvCxnSpPr/>
            <p:nvPr/>
          </p:nvCxnSpPr>
          <p:spPr>
            <a:xfrm>
              <a:off x="2309169" y="4880824"/>
              <a:ext cx="129693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1 115"/>
            <p:cNvCxnSpPr/>
            <p:nvPr/>
          </p:nvCxnSpPr>
          <p:spPr>
            <a:xfrm>
              <a:off x="3629552" y="4881482"/>
              <a:ext cx="0" cy="433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>
              <a:off x="2339513" y="4880824"/>
              <a:ext cx="0" cy="433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uppo 108"/>
          <p:cNvGrpSpPr/>
          <p:nvPr/>
        </p:nvGrpSpPr>
        <p:grpSpPr>
          <a:xfrm>
            <a:off x="1768920" y="1641219"/>
            <a:ext cx="205056" cy="26307"/>
            <a:chOff x="2335325" y="4880824"/>
            <a:chExt cx="1296937" cy="44047"/>
          </a:xfrm>
        </p:grpSpPr>
        <p:cxnSp>
          <p:nvCxnSpPr>
            <p:cNvPr id="112" name="Connettore 1 111"/>
            <p:cNvCxnSpPr/>
            <p:nvPr/>
          </p:nvCxnSpPr>
          <p:spPr>
            <a:xfrm>
              <a:off x="2335325" y="4880824"/>
              <a:ext cx="1296937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1 112"/>
            <p:cNvCxnSpPr/>
            <p:nvPr/>
          </p:nvCxnSpPr>
          <p:spPr>
            <a:xfrm>
              <a:off x="3629552" y="4881482"/>
              <a:ext cx="0" cy="433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>
              <a:off x="2339513" y="4880824"/>
              <a:ext cx="0" cy="433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0" name="Connettore 1 109"/>
          <p:cNvCxnSpPr/>
          <p:nvPr/>
        </p:nvCxnSpPr>
        <p:spPr>
          <a:xfrm flipV="1">
            <a:off x="2373681" y="1622197"/>
            <a:ext cx="0" cy="135468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Connettore 1 110"/>
          <p:cNvCxnSpPr/>
          <p:nvPr/>
        </p:nvCxnSpPr>
        <p:spPr>
          <a:xfrm>
            <a:off x="1857801" y="1618320"/>
            <a:ext cx="53186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40">
            <a:extLst>
              <a:ext uri="{FF2B5EF4-FFF2-40B4-BE49-F238E27FC236}">
                <a16:creationId xmlns="" xmlns:a16="http://schemas.microsoft.com/office/drawing/2014/main" id="{9179058E-AC30-B14F-93B3-C36A99FFBE88}"/>
              </a:ext>
            </a:extLst>
          </p:cNvPr>
          <p:cNvSpPr txBox="1"/>
          <p:nvPr/>
        </p:nvSpPr>
        <p:spPr>
          <a:xfrm flipH="1">
            <a:off x="1932752" y="1481052"/>
            <a:ext cx="243978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0" name="TextBox 40">
            <a:extLst>
              <a:ext uri="{FF2B5EF4-FFF2-40B4-BE49-F238E27FC236}">
                <a16:creationId xmlns="" xmlns:a16="http://schemas.microsoft.com/office/drawing/2014/main" id="{9179058E-AC30-B14F-93B3-C36A99FFBE88}"/>
              </a:ext>
            </a:extLst>
          </p:cNvPr>
          <p:cNvSpPr txBox="1"/>
          <p:nvPr/>
        </p:nvSpPr>
        <p:spPr>
          <a:xfrm flipH="1">
            <a:off x="2015735" y="1481674"/>
            <a:ext cx="243978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810367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568437" y="4247687"/>
            <a:ext cx="205003" cy="313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34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-117718" y="-108908"/>
            <a:ext cx="1167307" cy="3639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765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765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76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465936" y="1036318"/>
            <a:ext cx="205003" cy="313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34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1616841" y="4720039"/>
            <a:ext cx="3318573" cy="2438668"/>
            <a:chOff x="1465330" y="5179490"/>
            <a:chExt cx="3704064" cy="2721948"/>
          </a:xfrm>
        </p:grpSpPr>
        <p:sp>
          <p:nvSpPr>
            <p:cNvPr id="23" name="CasellaDiTesto 22"/>
            <p:cNvSpPr txBox="1"/>
            <p:nvPr/>
          </p:nvSpPr>
          <p:spPr>
            <a:xfrm>
              <a:off x="2440356" y="7613733"/>
              <a:ext cx="1955965" cy="287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75" dirty="0" err="1">
                  <a:latin typeface="Arial" panose="020B0604020202020204" pitchFamily="34" charset="0"/>
                  <a:cs typeface="Arial" panose="020B0604020202020204" pitchFamily="34" charset="0"/>
                </a:rPr>
                <a:t>folds</a:t>
              </a:r>
              <a:r>
                <a:rPr lang="it-IT" sz="1075" dirty="0">
                  <a:latin typeface="Arial" panose="020B0604020202020204" pitchFamily="34" charset="0"/>
                  <a:cs typeface="Arial" panose="020B0604020202020204" pitchFamily="34" charset="0"/>
                </a:rPr>
                <a:t> over </a:t>
              </a:r>
              <a:r>
                <a:rPr lang="it-IT" sz="1075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it-IT" sz="1075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075" dirty="0" err="1">
                  <a:latin typeface="Arial" panose="020B0604020202020204" pitchFamily="34" charset="0"/>
                  <a:cs typeface="Arial" panose="020B0604020202020204" pitchFamily="34" charset="0"/>
                </a:rPr>
                <a:t>Affymetrix</a:t>
              </a:r>
              <a:r>
                <a:rPr lang="it-IT" sz="10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 rot="16200000">
              <a:off x="623149" y="6348251"/>
              <a:ext cx="1972068" cy="287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75" dirty="0" err="1">
                  <a:latin typeface="Arial" panose="020B0604020202020204" pitchFamily="34" charset="0"/>
                  <a:cs typeface="Arial" panose="020B0604020202020204" pitchFamily="34" charset="0"/>
                </a:rPr>
                <a:t>folds</a:t>
              </a:r>
              <a:r>
                <a:rPr lang="it-IT" sz="1075" dirty="0">
                  <a:latin typeface="Arial" panose="020B0604020202020204" pitchFamily="34" charset="0"/>
                  <a:cs typeface="Arial" panose="020B0604020202020204" pitchFamily="34" charset="0"/>
                </a:rPr>
                <a:t> over </a:t>
              </a:r>
              <a:r>
                <a:rPr lang="it-IT" sz="1075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it-IT" sz="1075" dirty="0">
                  <a:latin typeface="Arial" panose="020B0604020202020204" pitchFamily="34" charset="0"/>
                  <a:cs typeface="Arial" panose="020B0604020202020204" pitchFamily="34" charset="0"/>
                </a:rPr>
                <a:t> (QRT-PCR)</a:t>
              </a:r>
              <a:endParaRPr lang="en-US" sz="10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Immagine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57" b="11164"/>
            <a:stretch/>
          </p:blipFill>
          <p:spPr>
            <a:xfrm>
              <a:off x="1747683" y="5179490"/>
              <a:ext cx="3421711" cy="2434244"/>
            </a:xfrm>
            <a:prstGeom prst="rect">
              <a:avLst/>
            </a:prstGeom>
          </p:spPr>
        </p:pic>
        <p:sp>
          <p:nvSpPr>
            <p:cNvPr id="9" name="CasellaDiTesto 8"/>
            <p:cNvSpPr txBox="1"/>
            <p:nvPr/>
          </p:nvSpPr>
          <p:spPr>
            <a:xfrm>
              <a:off x="3715352" y="7059736"/>
              <a:ext cx="1331531" cy="287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75" i="1" dirty="0">
                  <a:latin typeface="Arial" panose="020B0604020202020204" pitchFamily="34" charset="0"/>
                  <a:cs typeface="Arial" panose="020B0604020202020204" pitchFamily="34" charset="0"/>
                </a:rPr>
                <a:t>r </a:t>
              </a:r>
              <a:r>
                <a:rPr lang="it-IT" sz="1075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quare</a:t>
              </a:r>
              <a:r>
                <a:rPr lang="it-IT" sz="1075" i="1" dirty="0">
                  <a:latin typeface="Arial" panose="020B0604020202020204" pitchFamily="34" charset="0"/>
                  <a:cs typeface="Arial" panose="020B0604020202020204" pitchFamily="34" charset="0"/>
                </a:rPr>
                <a:t>: 0.7943</a:t>
              </a:r>
              <a:endParaRPr lang="en-US" sz="10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6" name="Grafico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680063"/>
              </p:ext>
            </p:extLst>
          </p:nvPr>
        </p:nvGraphicFramePr>
        <p:xfrm>
          <a:off x="670937" y="1427202"/>
          <a:ext cx="5420581" cy="2231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0194138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-73627" y="-85725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4" t="5177" r="7654" b="5404"/>
          <a:stretch/>
        </p:blipFill>
        <p:spPr>
          <a:xfrm>
            <a:off x="65684" y="1105232"/>
            <a:ext cx="6792315" cy="3609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09825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7DC2CDE34BB87479B9936A53DF00BD6" ma:contentTypeVersion="10" ma:contentTypeDescription="Create a new document." ma:contentTypeScope="" ma:versionID="4d7a215f93ac8711030902ead3adf41b">
  <xsd:schema xmlns:xsd="http://www.w3.org/2001/XMLSchema" xmlns:xs="http://www.w3.org/2001/XMLSchema" xmlns:p="http://schemas.microsoft.com/office/2006/metadata/properties" xmlns:ns3="d193f1a8-93cd-481b-b4fd-b93e55c33ad4" targetNamespace="http://schemas.microsoft.com/office/2006/metadata/properties" ma:root="true" ma:fieldsID="ef20d243c285a38279ae3ee0721caab4" ns3:_="">
    <xsd:import namespace="d193f1a8-93cd-481b-b4fd-b93e55c33ad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193f1a8-93cd-481b-b4fd-b93e55c33ad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FDA9718-4919-4759-914A-5BAD6DD4164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193f1a8-93cd-481b-b4fd-b93e55c33ad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45A9D18-6D46-4923-8774-A0E029AE3C83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d193f1a8-93cd-481b-b4fd-b93e55c33ad4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2F46B2EA-17C0-400B-8895-F281EAB0CB7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77</TotalTime>
  <Words>234</Words>
  <Application>Microsoft Office PowerPoint</Application>
  <PresentationFormat>A4 (21x29,7 cm)</PresentationFormat>
  <Paragraphs>22</Paragraphs>
  <Slides>3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oce Mario</dc:creator>
  <cp:lastModifiedBy>Cioce Mario</cp:lastModifiedBy>
  <cp:revision>521</cp:revision>
  <dcterms:created xsi:type="dcterms:W3CDTF">2021-04-21T08:50:47Z</dcterms:created>
  <dcterms:modified xsi:type="dcterms:W3CDTF">2021-11-04T15:29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7DC2CDE34BB87479B9936A53DF00BD6</vt:lpwstr>
  </property>
</Properties>
</file>